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2" r:id="rId2"/>
    <p:sldId id="276" r:id="rId3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121" autoAdjust="0"/>
    <p:restoredTop sz="94660"/>
  </p:normalViewPr>
  <p:slideViewPr>
    <p:cSldViewPr snapToGrid="0">
      <p:cViewPr>
        <p:scale>
          <a:sx n="98" d="100"/>
          <a:sy n="98" d="100"/>
        </p:scale>
        <p:origin x="-426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690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399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70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93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243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193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865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960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540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402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594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89EBEE-7BE7-4671-AE4F-0B2328086A59}" type="datetimeFigureOut">
              <a:rPr lang="en-US" smtClean="0"/>
              <a:t>6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7CE8A-CAAA-4709-B183-121CC0301C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735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04441" y="1895493"/>
            <a:ext cx="8137362" cy="3318532"/>
            <a:chOff x="2570780" y="601951"/>
            <a:chExt cx="8137362" cy="3318532"/>
          </a:xfrm>
        </p:grpSpPr>
        <p:sp>
          <p:nvSpPr>
            <p:cNvPr id="8" name="Rectangle 7"/>
            <p:cNvSpPr/>
            <p:nvPr/>
          </p:nvSpPr>
          <p:spPr>
            <a:xfrm>
              <a:off x="7875649" y="979834"/>
              <a:ext cx="90433" cy="276490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6374083" y="1008992"/>
              <a:ext cx="2200072" cy="2678250"/>
              <a:chOff x="6374083" y="1414345"/>
              <a:chExt cx="2200072" cy="2791398"/>
            </a:xfrm>
          </p:grpSpPr>
          <p:sp>
            <p:nvSpPr>
              <p:cNvPr id="15" name="Rectangle 14"/>
              <p:cNvSpPr/>
              <p:nvPr/>
            </p:nvSpPr>
            <p:spPr>
              <a:xfrm>
                <a:off x="6385217" y="1414345"/>
                <a:ext cx="356487" cy="2546089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6832422" y="1414345"/>
                <a:ext cx="126808" cy="2546089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7064955" y="1414345"/>
                <a:ext cx="289635" cy="2546089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7434231" y="1414345"/>
                <a:ext cx="152892" cy="2546089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8050926" y="1414345"/>
                <a:ext cx="284285" cy="2546089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8506099" y="1414345"/>
                <a:ext cx="68056" cy="2546089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7677348" y="1414345"/>
                <a:ext cx="132624" cy="2546089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8506099" y="4048981"/>
                <a:ext cx="66001" cy="156762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8200633" y="4048981"/>
                <a:ext cx="128618" cy="156762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8048276" y="4048981"/>
                <a:ext cx="66001" cy="156762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7667323" y="4048981"/>
                <a:ext cx="141480" cy="156762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7060659" y="4048981"/>
                <a:ext cx="207141" cy="156762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6374083" y="4048981"/>
                <a:ext cx="366964" cy="156762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7433956" y="4048981"/>
                <a:ext cx="141480" cy="156762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6826730" y="4048981"/>
                <a:ext cx="141480" cy="156762"/>
              </a:xfrm>
              <a:prstGeom prst="rect">
                <a:avLst/>
              </a:prstGeom>
              <a:solidFill>
                <a:schemeClr val="accent1">
                  <a:alpha val="3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4305799" y="3497803"/>
              <a:ext cx="1031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Human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570780" y="741230"/>
              <a:ext cx="1657494" cy="2893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Order</a:t>
              </a: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Cyprinoformes</a:t>
              </a:r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Clupiformes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Characiformes</a:t>
              </a:r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Esociformes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almoniformes</a:t>
              </a:r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etraodontiformes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Cyprinodontiformes</a:t>
              </a:r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Beloniformes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leuronectiformes</a:t>
              </a:r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r>
                <a:rPr lang="en-US" sz="1000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erciformes</a:t>
              </a:r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r"/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9416920" y="741230"/>
              <a:ext cx="1291222" cy="30469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ccession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05172568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12691950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07258019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10878224</a:t>
              </a:r>
            </a:p>
            <a:p>
              <a:r>
                <a:rPr lang="en-US" sz="10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KX372300*</a:t>
              </a:r>
            </a:p>
            <a:p>
              <a:r>
                <a:rPr lang="en-US" sz="10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KX372301*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CI32961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03961876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08397047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04081819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08326540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10792797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10736070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08304424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04557829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XP_003447344</a:t>
              </a:r>
            </a:p>
            <a:p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2570780" y="601951"/>
              <a:ext cx="8137362" cy="33185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663538" y="741230"/>
              <a:ext cx="3613089" cy="27392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DLGex</a:t>
              </a:r>
              <a:r>
                <a:rPr lang="en-US" sz="12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motif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SQQDMDLIDILWRQDVDLGAGREVFDFSYRQKEVELRRRREQEE</a:t>
              </a:r>
            </a:p>
            <a:p>
              <a:r>
                <a:rPr lang="en-US" sz="10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PSQQDMDMIDILWKQDIDLGAGREVFDFSYRQKEHELQKQRDLEE</a:t>
              </a:r>
              <a:endParaRPr lang="en-US" sz="1000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SQQDMDLIDILWRQDIDLGAGREVFDFSYRQKEVQLQRQREL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SQQDVDLIDILWRQDIDLGAGREMFDYCHRQKEHELQRQREQD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SQQDIDLIDILWRQDIDLGAGREVFDYCQRQKEHELQQQREQ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SQQDVDLIDILWRQDIDLGAGREVFDYCHRQKEHELQRQRMQ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SQQDIDLIDILWRQDIDLGAGREVFDYCQRQKEHELQQQREQ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IQQDMNLIDILWKQDIDLGASREVFDYNHRQKEHELQRQLEQQ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TQKDMDLIDILWNQDIDLGARREVFDINHRQKEHELRRQREL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DSNQDLDLIDILWKQDIDLGARREVFDYNHRQKEHELQRQRQL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MMQDMDLIDILWKQDIDLGACREVFDYNHRQKEHELQRQREL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GQQEMELIDILWNQDIDLGARREVFDYNHRQKEHELRRQREL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SQQDMNLIDILWKQDIDLGARREVFDYNHRQKEHELQRQLEL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SQQDMDLIDILWKQDIDLGARREVFDYNHRQKEHELRRQQEL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GQQDMDLIDILWKQDIDLGARREVFDYNHRQKEHELQRQRELEE</a:t>
              </a:r>
            </a:p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GQQDMDLIDILWKQDIDLGARREVFDYNHRQKEHELQRQRELEE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314171" y="741230"/>
              <a:ext cx="1291222" cy="27392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enus</a:t>
              </a:r>
            </a:p>
            <a:p>
              <a:r>
                <a:rPr lang="en-US" sz="1000" i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Danio </a:t>
              </a:r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rerio</a:t>
              </a:r>
              <a:r>
                <a:rPr lang="en-US" sz="1000" i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a</a:t>
              </a:r>
              <a:r>
                <a:rPr lang="en-US" sz="1000" i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Clupea</a:t>
              </a:r>
              <a:endParaRPr lang="en-US" sz="1000" i="1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styanax</a:t>
              </a: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Esox</a:t>
              </a:r>
              <a:endParaRPr lang="en-US" sz="1000" i="1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Oncorhychus</a:t>
              </a:r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2A </a:t>
              </a:r>
              <a:r>
                <a:rPr lang="en-US" sz="1000" i="1" dirty="0" err="1">
                  <a:latin typeface="Courier New" panose="02070309020205020404" pitchFamily="49" charset="0"/>
                  <a:cs typeface="Courier New" panose="02070309020205020404" pitchFamily="49" charset="0"/>
                </a:rPr>
                <a:t>Oncorhychus</a:t>
              </a:r>
              <a:r>
                <a:rPr lang="en-US" sz="10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2B</a:t>
              </a:r>
            </a:p>
            <a:p>
              <a:r>
                <a:rPr lang="en-US" sz="1000" i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almo </a:t>
              </a:r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alar</a:t>
              </a:r>
              <a:endParaRPr lang="en-US" sz="1000" i="1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akifugu</a:t>
              </a:r>
              <a:endParaRPr lang="en-US" sz="1000" i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oecilia</a:t>
              </a:r>
              <a:endParaRPr lang="en-US" sz="1000" i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Oryzias</a:t>
              </a:r>
              <a:endParaRPr lang="en-US" sz="1000" i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Cynoglossus</a:t>
              </a:r>
              <a:endParaRPr lang="en-US" sz="1000" i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Notothenia</a:t>
              </a:r>
              <a:endParaRPr lang="en-US" sz="1000" i="1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Larimichthys</a:t>
              </a:r>
              <a:endParaRPr lang="en-US" sz="1000" i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tegastes</a:t>
              </a:r>
              <a:endParaRPr lang="en-US" sz="1000" i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Maylandia</a:t>
              </a:r>
              <a:endParaRPr lang="en-US" sz="1000" i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sz="1000" i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Oreochromis</a:t>
              </a:r>
              <a:endParaRPr lang="en-US" sz="1000" i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664114" y="3497803"/>
              <a:ext cx="36488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PSQQD</a:t>
              </a:r>
              <a:r>
                <a:rPr lang="en-US" sz="1000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MDLIDILWRQDIDLGVSREVFDFSQRRKETELEKQ</a:t>
              </a:r>
              <a:r>
                <a:rPr lang="en-US" sz="10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KKLEK</a:t>
              </a:r>
              <a:endParaRPr lang="en-US" sz="10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sp>
        <p:nvSpPr>
          <p:cNvPr id="56" name="TextBox 55"/>
          <p:cNvSpPr txBox="1"/>
          <p:nvPr/>
        </p:nvSpPr>
        <p:spPr>
          <a:xfrm>
            <a:off x="814041" y="223855"/>
            <a:ext cx="23023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09. 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9890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892578" y="1580321"/>
            <a:ext cx="4762943" cy="4657466"/>
            <a:chOff x="3546890" y="1133128"/>
            <a:chExt cx="4762943" cy="4657466"/>
          </a:xfrm>
        </p:grpSpPr>
        <p:sp>
          <p:nvSpPr>
            <p:cNvPr id="164" name="Rectangle 163"/>
            <p:cNvSpPr/>
            <p:nvPr/>
          </p:nvSpPr>
          <p:spPr>
            <a:xfrm flipV="1">
              <a:off x="7650605" y="3375161"/>
              <a:ext cx="296214" cy="1828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Straight Connector 165"/>
            <p:cNvCxnSpPr/>
            <p:nvPr/>
          </p:nvCxnSpPr>
          <p:spPr>
            <a:xfrm flipH="1">
              <a:off x="4888885" y="1574032"/>
              <a:ext cx="988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 flipH="1">
              <a:off x="4888885" y="2178160"/>
              <a:ext cx="988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>
            <a:xfrm flipH="1">
              <a:off x="4888885" y="2789322"/>
              <a:ext cx="988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/>
            <p:cNvCxnSpPr/>
            <p:nvPr/>
          </p:nvCxnSpPr>
          <p:spPr>
            <a:xfrm flipH="1" flipV="1">
              <a:off x="5002202" y="3392867"/>
              <a:ext cx="3196753" cy="58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/>
            <p:cNvCxnSpPr/>
            <p:nvPr/>
          </p:nvCxnSpPr>
          <p:spPr>
            <a:xfrm rot="5400000" flipH="1">
              <a:off x="3952434" y="2347310"/>
              <a:ext cx="208709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/>
            <p:cNvSpPr txBox="1"/>
            <p:nvPr/>
          </p:nvSpPr>
          <p:spPr>
            <a:xfrm>
              <a:off x="4641061" y="2610073"/>
              <a:ext cx="4381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4641074" y="1992513"/>
              <a:ext cx="4381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4641076" y="1388387"/>
              <a:ext cx="4381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4612240" y="3492868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Parallelogram 180"/>
            <p:cNvSpPr/>
            <p:nvPr/>
          </p:nvSpPr>
          <p:spPr>
            <a:xfrm>
              <a:off x="4373835" y="3396803"/>
              <a:ext cx="1284459" cy="1182633"/>
            </a:xfrm>
            <a:prstGeom prst="parallelogram">
              <a:avLst>
                <a:gd name="adj" fmla="val 84259"/>
              </a:avLst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Parallelogram 181"/>
            <p:cNvSpPr/>
            <p:nvPr/>
          </p:nvSpPr>
          <p:spPr>
            <a:xfrm>
              <a:off x="5178304" y="3394528"/>
              <a:ext cx="952183" cy="755853"/>
            </a:xfrm>
            <a:prstGeom prst="parallelogram">
              <a:avLst>
                <a:gd name="adj" fmla="val 84874"/>
              </a:avLst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Parallelogram 182"/>
            <p:cNvSpPr/>
            <p:nvPr/>
          </p:nvSpPr>
          <p:spPr>
            <a:xfrm>
              <a:off x="5863998" y="3396456"/>
              <a:ext cx="720608" cy="490910"/>
            </a:xfrm>
            <a:prstGeom prst="parallelogram">
              <a:avLst>
                <a:gd name="adj" fmla="val 85997"/>
              </a:avLst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Parallelogram 183"/>
            <p:cNvSpPr/>
            <p:nvPr/>
          </p:nvSpPr>
          <p:spPr>
            <a:xfrm>
              <a:off x="6687029" y="3396803"/>
              <a:ext cx="353004" cy="61237"/>
            </a:xfrm>
            <a:prstGeom prst="parallelogram">
              <a:avLst>
                <a:gd name="adj" fmla="val 76445"/>
              </a:avLst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Parallelogram 185"/>
            <p:cNvSpPr/>
            <p:nvPr/>
          </p:nvSpPr>
          <p:spPr>
            <a:xfrm>
              <a:off x="5981872" y="3394502"/>
              <a:ext cx="1506979" cy="1447756"/>
            </a:xfrm>
            <a:prstGeom prst="parallelogram">
              <a:avLst>
                <a:gd name="adj" fmla="val 83945"/>
              </a:avLst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5178303" y="1600331"/>
              <a:ext cx="5725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dx1</a:t>
              </a:r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5611511" y="1798436"/>
              <a:ext cx="5725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stp</a:t>
              </a:r>
              <a:endParaRPr lang="en-US" sz="1000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6122243" y="2768085"/>
              <a:ext cx="5725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mox1</a:t>
              </a: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6523186" y="2922833"/>
              <a:ext cx="5725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str</a:t>
              </a:r>
              <a:endParaRPr lang="en-US" sz="1000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6971176" y="2979105"/>
              <a:ext cx="5725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clc</a:t>
              </a:r>
              <a:endParaRPr lang="en-US" sz="1000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7536491" y="3035377"/>
              <a:ext cx="57250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GL3 -</a:t>
              </a:r>
            </a:p>
          </p:txBody>
        </p:sp>
        <p:sp>
          <p:nvSpPr>
            <p:cNvPr id="219" name="Parallelogram 218"/>
            <p:cNvSpPr/>
            <p:nvPr/>
          </p:nvSpPr>
          <p:spPr>
            <a:xfrm>
              <a:off x="4478494" y="3391033"/>
              <a:ext cx="1181624" cy="1064285"/>
            </a:xfrm>
            <a:prstGeom prst="parallelogram">
              <a:avLst>
                <a:gd name="adj" fmla="val 83757"/>
              </a:avLst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Parallelogram 219"/>
            <p:cNvSpPr/>
            <p:nvPr/>
          </p:nvSpPr>
          <p:spPr>
            <a:xfrm>
              <a:off x="5392340" y="3393624"/>
              <a:ext cx="742766" cy="500666"/>
            </a:xfrm>
            <a:prstGeom prst="parallelogram">
              <a:avLst>
                <a:gd name="adj" fmla="val 87023"/>
              </a:avLst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Parallelogram 220"/>
            <p:cNvSpPr/>
            <p:nvPr/>
          </p:nvSpPr>
          <p:spPr>
            <a:xfrm>
              <a:off x="5611862" y="3387432"/>
              <a:ext cx="972387" cy="783430"/>
            </a:xfrm>
            <a:prstGeom prst="parallelogram">
              <a:avLst>
                <a:gd name="adj" fmla="val 86922"/>
              </a:avLst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Parallelogram 221"/>
            <p:cNvSpPr/>
            <p:nvPr/>
          </p:nvSpPr>
          <p:spPr>
            <a:xfrm>
              <a:off x="6691649" y="3391033"/>
              <a:ext cx="353004" cy="61237"/>
            </a:xfrm>
            <a:prstGeom prst="parallelogram">
              <a:avLst>
                <a:gd name="adj" fmla="val 76445"/>
              </a:avLst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Parallelogram 222"/>
            <p:cNvSpPr/>
            <p:nvPr/>
          </p:nvSpPr>
          <p:spPr>
            <a:xfrm>
              <a:off x="6050256" y="3392495"/>
              <a:ext cx="1438595" cy="1370486"/>
            </a:xfrm>
            <a:prstGeom prst="parallelogram">
              <a:avLst>
                <a:gd name="adj" fmla="val 84151"/>
              </a:avLst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5" name="Straight Connector 224"/>
            <p:cNvCxnSpPr/>
            <p:nvPr/>
          </p:nvCxnSpPr>
          <p:spPr>
            <a:xfrm flipH="1">
              <a:off x="3549745" y="3388267"/>
              <a:ext cx="1446298" cy="17219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7" name="Group 246"/>
            <p:cNvGrpSpPr/>
            <p:nvPr/>
          </p:nvGrpSpPr>
          <p:grpSpPr>
            <a:xfrm>
              <a:off x="3668020" y="3527331"/>
              <a:ext cx="1350376" cy="1440880"/>
              <a:chOff x="2973314" y="5096734"/>
              <a:chExt cx="1350376" cy="1440880"/>
            </a:xfrm>
          </p:grpSpPr>
          <p:cxnSp>
            <p:nvCxnSpPr>
              <p:cNvPr id="234" name="Straight Connector 233"/>
              <p:cNvCxnSpPr/>
              <p:nvPr/>
            </p:nvCxnSpPr>
            <p:spPr>
              <a:xfrm flipH="1">
                <a:off x="4188660" y="5096734"/>
                <a:ext cx="13503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Straight Connector 234"/>
              <p:cNvCxnSpPr/>
              <p:nvPr/>
            </p:nvCxnSpPr>
            <p:spPr>
              <a:xfrm flipH="1">
                <a:off x="4074734" y="5243939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Straight Connector 235"/>
              <p:cNvCxnSpPr/>
              <p:nvPr/>
            </p:nvCxnSpPr>
            <p:spPr>
              <a:xfrm flipH="1">
                <a:off x="3952354" y="5385949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Straight Connector 236"/>
              <p:cNvCxnSpPr/>
              <p:nvPr/>
            </p:nvCxnSpPr>
            <p:spPr>
              <a:xfrm flipH="1">
                <a:off x="3829974" y="553315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Straight Connector 237"/>
              <p:cNvCxnSpPr/>
              <p:nvPr/>
            </p:nvCxnSpPr>
            <p:spPr>
              <a:xfrm flipH="1">
                <a:off x="3707594" y="567516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Straight Connector 238"/>
              <p:cNvCxnSpPr/>
              <p:nvPr/>
            </p:nvCxnSpPr>
            <p:spPr>
              <a:xfrm flipH="1">
                <a:off x="3585214" y="581717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Straight Connector 239"/>
              <p:cNvCxnSpPr/>
              <p:nvPr/>
            </p:nvCxnSpPr>
            <p:spPr>
              <a:xfrm flipH="1">
                <a:off x="3462834" y="595918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Straight Connector 240"/>
              <p:cNvCxnSpPr/>
              <p:nvPr/>
            </p:nvCxnSpPr>
            <p:spPr>
              <a:xfrm flipH="1">
                <a:off x="3340454" y="6106389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Straight Connector 241"/>
              <p:cNvCxnSpPr/>
              <p:nvPr/>
            </p:nvCxnSpPr>
            <p:spPr>
              <a:xfrm flipH="1">
                <a:off x="3218074" y="625359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Straight Connector 242"/>
              <p:cNvCxnSpPr/>
              <p:nvPr/>
            </p:nvCxnSpPr>
            <p:spPr>
              <a:xfrm flipH="1">
                <a:off x="3095694" y="639560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Straight Connector 243"/>
              <p:cNvCxnSpPr/>
              <p:nvPr/>
            </p:nvCxnSpPr>
            <p:spPr>
              <a:xfrm flipH="1">
                <a:off x="2973314" y="653761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4" name="TextBox 253"/>
            <p:cNvSpPr txBox="1"/>
            <p:nvPr/>
          </p:nvSpPr>
          <p:spPr>
            <a:xfrm>
              <a:off x="4349900" y="3788263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TextBox 254"/>
            <p:cNvSpPr txBox="1"/>
            <p:nvPr/>
          </p:nvSpPr>
          <p:spPr>
            <a:xfrm>
              <a:off x="4117056" y="4083658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TextBox 255"/>
            <p:cNvSpPr txBox="1"/>
            <p:nvPr/>
          </p:nvSpPr>
          <p:spPr>
            <a:xfrm>
              <a:off x="3884212" y="4364305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3585002" y="4637578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Parallelogram 261"/>
            <p:cNvSpPr/>
            <p:nvPr/>
          </p:nvSpPr>
          <p:spPr>
            <a:xfrm>
              <a:off x="4793469" y="4822886"/>
              <a:ext cx="353004" cy="61237"/>
            </a:xfrm>
            <a:prstGeom prst="parallelogram">
              <a:avLst>
                <a:gd name="adj" fmla="val 76445"/>
              </a:avLst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Parallelogram 262"/>
            <p:cNvSpPr/>
            <p:nvPr/>
          </p:nvSpPr>
          <p:spPr>
            <a:xfrm>
              <a:off x="4651521" y="4949370"/>
              <a:ext cx="353004" cy="61237"/>
            </a:xfrm>
            <a:prstGeom prst="parallelogram">
              <a:avLst>
                <a:gd name="adj" fmla="val 76445"/>
              </a:avLst>
            </a:prstGeom>
            <a:noFill/>
            <a:ln w="63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TextBox 263"/>
            <p:cNvSpPr txBox="1"/>
            <p:nvPr/>
          </p:nvSpPr>
          <p:spPr>
            <a:xfrm>
              <a:off x="5159491" y="4710106"/>
              <a:ext cx="745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rf2A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TextBox 264"/>
            <p:cNvSpPr txBox="1"/>
            <p:nvPr/>
          </p:nvSpPr>
          <p:spPr>
            <a:xfrm>
              <a:off x="5032491" y="4853224"/>
              <a:ext cx="745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rf2B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3" name="Group 142"/>
            <p:cNvGrpSpPr/>
            <p:nvPr/>
          </p:nvGrpSpPr>
          <p:grpSpPr>
            <a:xfrm rot="16200000">
              <a:off x="4736198" y="2463446"/>
              <a:ext cx="1563792" cy="296214"/>
              <a:chOff x="5404544" y="1623315"/>
              <a:chExt cx="1563792" cy="296214"/>
            </a:xfrm>
          </p:grpSpPr>
          <p:grpSp>
            <p:nvGrpSpPr>
              <p:cNvPr id="144" name="Group 143"/>
              <p:cNvGrpSpPr/>
              <p:nvPr/>
            </p:nvGrpSpPr>
            <p:grpSpPr>
              <a:xfrm rot="5400000">
                <a:off x="6675965" y="1531468"/>
                <a:ext cx="96581" cy="488161"/>
                <a:chOff x="6550445" y="5355891"/>
                <a:chExt cx="96581" cy="488161"/>
              </a:xfrm>
            </p:grpSpPr>
            <p:cxnSp>
              <p:nvCxnSpPr>
                <p:cNvPr id="146" name="Straight Connector 145"/>
                <p:cNvCxnSpPr/>
                <p:nvPr/>
              </p:nvCxnSpPr>
              <p:spPr>
                <a:xfrm>
                  <a:off x="6594438" y="5355891"/>
                  <a:ext cx="0" cy="48816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7" name="Straight Connector 146"/>
                <p:cNvCxnSpPr/>
                <p:nvPr/>
              </p:nvCxnSpPr>
              <p:spPr>
                <a:xfrm rot="5400000">
                  <a:off x="6598736" y="5307601"/>
                  <a:ext cx="0" cy="9658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" name="Rectangle 144"/>
              <p:cNvSpPr/>
              <p:nvPr/>
            </p:nvSpPr>
            <p:spPr>
              <a:xfrm rot="5400000">
                <a:off x="5909747" y="1118112"/>
                <a:ext cx="296214" cy="130662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8" name="Group 147"/>
            <p:cNvGrpSpPr/>
            <p:nvPr/>
          </p:nvGrpSpPr>
          <p:grpSpPr>
            <a:xfrm rot="16200000">
              <a:off x="5334365" y="2605489"/>
              <a:ext cx="1279705" cy="296214"/>
              <a:chOff x="5404543" y="1998495"/>
              <a:chExt cx="1279705" cy="296214"/>
            </a:xfrm>
          </p:grpSpPr>
          <p:grpSp>
            <p:nvGrpSpPr>
              <p:cNvPr id="149" name="Group 148"/>
              <p:cNvGrpSpPr/>
              <p:nvPr/>
            </p:nvGrpSpPr>
            <p:grpSpPr>
              <a:xfrm rot="5400000">
                <a:off x="6391877" y="1914473"/>
                <a:ext cx="96581" cy="488161"/>
                <a:chOff x="6550445" y="5355891"/>
                <a:chExt cx="96581" cy="488161"/>
              </a:xfrm>
            </p:grpSpPr>
            <p:cxnSp>
              <p:nvCxnSpPr>
                <p:cNvPr id="151" name="Straight Connector 150"/>
                <p:cNvCxnSpPr/>
                <p:nvPr/>
              </p:nvCxnSpPr>
              <p:spPr>
                <a:xfrm>
                  <a:off x="6594438" y="5355891"/>
                  <a:ext cx="0" cy="48816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2" name="Straight Connector 151"/>
                <p:cNvCxnSpPr/>
                <p:nvPr/>
              </p:nvCxnSpPr>
              <p:spPr>
                <a:xfrm rot="5400000">
                  <a:off x="6598736" y="5307601"/>
                  <a:ext cx="0" cy="9658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0" name="Rectangle 149"/>
              <p:cNvSpPr/>
              <p:nvPr/>
            </p:nvSpPr>
            <p:spPr>
              <a:xfrm rot="5400000">
                <a:off x="5790735" y="1612303"/>
                <a:ext cx="296214" cy="106859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9" name="Group 158"/>
            <p:cNvGrpSpPr/>
            <p:nvPr/>
          </p:nvGrpSpPr>
          <p:grpSpPr>
            <a:xfrm rot="16200000">
              <a:off x="6257975" y="3072975"/>
              <a:ext cx="344733" cy="296214"/>
              <a:chOff x="5404544" y="3427572"/>
              <a:chExt cx="344733" cy="296214"/>
            </a:xfrm>
          </p:grpSpPr>
          <p:grpSp>
            <p:nvGrpSpPr>
              <p:cNvPr id="160" name="Group 159"/>
              <p:cNvGrpSpPr/>
              <p:nvPr/>
            </p:nvGrpSpPr>
            <p:grpSpPr>
              <a:xfrm rot="5400000">
                <a:off x="5558829" y="3421146"/>
                <a:ext cx="72739" cy="308157"/>
                <a:chOff x="6550445" y="5355891"/>
                <a:chExt cx="96581" cy="488161"/>
              </a:xfrm>
            </p:grpSpPr>
            <p:cxnSp>
              <p:nvCxnSpPr>
                <p:cNvPr id="162" name="Straight Connector 161"/>
                <p:cNvCxnSpPr/>
                <p:nvPr/>
              </p:nvCxnSpPr>
              <p:spPr>
                <a:xfrm>
                  <a:off x="6594438" y="5355891"/>
                  <a:ext cx="0" cy="48816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Straight Connector 162"/>
                <p:cNvCxnSpPr/>
                <p:nvPr/>
              </p:nvCxnSpPr>
              <p:spPr>
                <a:xfrm rot="5400000">
                  <a:off x="6598736" y="5307601"/>
                  <a:ext cx="0" cy="9658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1" name="Rectangle 160"/>
              <p:cNvSpPr/>
              <p:nvPr/>
            </p:nvSpPr>
            <p:spPr>
              <a:xfrm rot="5400000">
                <a:off x="5402487" y="3429629"/>
                <a:ext cx="296214" cy="2921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3" name="Group 152"/>
            <p:cNvGrpSpPr/>
            <p:nvPr/>
          </p:nvGrpSpPr>
          <p:grpSpPr>
            <a:xfrm rot="16200000">
              <a:off x="6836140" y="3195016"/>
              <a:ext cx="100652" cy="296214"/>
              <a:chOff x="5404544" y="3363854"/>
              <a:chExt cx="100652" cy="296214"/>
            </a:xfrm>
          </p:grpSpPr>
          <p:grpSp>
            <p:nvGrpSpPr>
              <p:cNvPr id="154" name="Group 153"/>
              <p:cNvGrpSpPr/>
              <p:nvPr/>
            </p:nvGrpSpPr>
            <p:grpSpPr>
              <a:xfrm rot="5400000">
                <a:off x="5445924" y="3495311"/>
                <a:ext cx="72739" cy="45805"/>
                <a:chOff x="6550445" y="5355891"/>
                <a:chExt cx="96581" cy="488161"/>
              </a:xfrm>
            </p:grpSpPr>
            <p:cxnSp>
              <p:nvCxnSpPr>
                <p:cNvPr id="156" name="Straight Connector 155"/>
                <p:cNvCxnSpPr/>
                <p:nvPr/>
              </p:nvCxnSpPr>
              <p:spPr>
                <a:xfrm>
                  <a:off x="6594438" y="5355891"/>
                  <a:ext cx="0" cy="48816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7" name="Straight Connector 156"/>
                <p:cNvCxnSpPr/>
                <p:nvPr/>
              </p:nvCxnSpPr>
              <p:spPr>
                <a:xfrm rot="5400000">
                  <a:off x="6598736" y="5307601"/>
                  <a:ext cx="0" cy="9658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5" name="Rectangle 154"/>
              <p:cNvSpPr/>
              <p:nvPr/>
            </p:nvSpPr>
            <p:spPr>
              <a:xfrm rot="5400000">
                <a:off x="5297585" y="3470813"/>
                <a:ext cx="296214" cy="82296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8" name="Rectangle 157"/>
            <p:cNvSpPr/>
            <p:nvPr/>
          </p:nvSpPr>
          <p:spPr>
            <a:xfrm flipV="1">
              <a:off x="7194483" y="3356873"/>
              <a:ext cx="296214" cy="3657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TextBox 267"/>
            <p:cNvSpPr txBox="1"/>
            <p:nvPr/>
          </p:nvSpPr>
          <p:spPr>
            <a:xfrm rot="16200000">
              <a:off x="3145708" y="1837027"/>
              <a:ext cx="1992573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stitutive promoter strength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TextBox 268"/>
            <p:cNvSpPr txBox="1"/>
            <p:nvPr/>
          </p:nvSpPr>
          <p:spPr>
            <a:xfrm rot="18550599">
              <a:off x="6811788" y="4446565"/>
              <a:ext cx="2103282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verage fold induction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0" name="Straight Connector 269"/>
            <p:cNvCxnSpPr/>
            <p:nvPr/>
          </p:nvCxnSpPr>
          <p:spPr>
            <a:xfrm flipH="1">
              <a:off x="6744051" y="3392417"/>
              <a:ext cx="1446298" cy="17219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71" name="Group 270"/>
            <p:cNvGrpSpPr/>
            <p:nvPr/>
          </p:nvGrpSpPr>
          <p:grpSpPr>
            <a:xfrm>
              <a:off x="6729106" y="3531481"/>
              <a:ext cx="1350376" cy="1440880"/>
              <a:chOff x="2973314" y="5096734"/>
              <a:chExt cx="1350376" cy="1440880"/>
            </a:xfrm>
          </p:grpSpPr>
          <p:cxnSp>
            <p:nvCxnSpPr>
              <p:cNvPr id="272" name="Straight Connector 271"/>
              <p:cNvCxnSpPr/>
              <p:nvPr/>
            </p:nvCxnSpPr>
            <p:spPr>
              <a:xfrm flipH="1">
                <a:off x="4188660" y="5096734"/>
                <a:ext cx="13503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Straight Connector 272"/>
              <p:cNvCxnSpPr/>
              <p:nvPr/>
            </p:nvCxnSpPr>
            <p:spPr>
              <a:xfrm flipH="1">
                <a:off x="4074734" y="5243939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Straight Connector 273"/>
              <p:cNvCxnSpPr/>
              <p:nvPr/>
            </p:nvCxnSpPr>
            <p:spPr>
              <a:xfrm flipH="1">
                <a:off x="3952354" y="5385949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Straight Connector 274"/>
              <p:cNvCxnSpPr/>
              <p:nvPr/>
            </p:nvCxnSpPr>
            <p:spPr>
              <a:xfrm flipH="1">
                <a:off x="3829974" y="553315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Straight Connector 275"/>
              <p:cNvCxnSpPr/>
              <p:nvPr/>
            </p:nvCxnSpPr>
            <p:spPr>
              <a:xfrm flipH="1">
                <a:off x="3707594" y="567516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Straight Connector 276"/>
              <p:cNvCxnSpPr/>
              <p:nvPr/>
            </p:nvCxnSpPr>
            <p:spPr>
              <a:xfrm flipH="1">
                <a:off x="3585214" y="581717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Straight Connector 277"/>
              <p:cNvCxnSpPr/>
              <p:nvPr/>
            </p:nvCxnSpPr>
            <p:spPr>
              <a:xfrm flipH="1">
                <a:off x="3462834" y="595918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Straight Connector 278"/>
              <p:cNvCxnSpPr/>
              <p:nvPr/>
            </p:nvCxnSpPr>
            <p:spPr>
              <a:xfrm flipH="1">
                <a:off x="3340454" y="6106389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Straight Connector 279"/>
              <p:cNvCxnSpPr/>
              <p:nvPr/>
            </p:nvCxnSpPr>
            <p:spPr>
              <a:xfrm flipH="1">
                <a:off x="3218074" y="625359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Straight Connector 280"/>
              <p:cNvCxnSpPr/>
              <p:nvPr/>
            </p:nvCxnSpPr>
            <p:spPr>
              <a:xfrm flipH="1">
                <a:off x="3095694" y="639560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Straight Connector 281"/>
              <p:cNvCxnSpPr/>
              <p:nvPr/>
            </p:nvCxnSpPr>
            <p:spPr>
              <a:xfrm flipH="1">
                <a:off x="2973314" y="6537614"/>
                <a:ext cx="12275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3" name="TextBox 282"/>
            <p:cNvSpPr txBox="1"/>
            <p:nvPr/>
          </p:nvSpPr>
          <p:spPr>
            <a:xfrm>
              <a:off x="7506886" y="3787437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7267822" y="4070392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TextBox 284"/>
            <p:cNvSpPr txBox="1"/>
            <p:nvPr/>
          </p:nvSpPr>
          <p:spPr>
            <a:xfrm>
              <a:off x="7034978" y="4362235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TextBox 285"/>
            <p:cNvSpPr txBox="1"/>
            <p:nvPr/>
          </p:nvSpPr>
          <p:spPr>
            <a:xfrm>
              <a:off x="6741988" y="4654168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8" name="Straight Arrow Connector 287"/>
            <p:cNvCxnSpPr/>
            <p:nvPr/>
          </p:nvCxnSpPr>
          <p:spPr>
            <a:xfrm flipH="1">
              <a:off x="7452045" y="3724761"/>
              <a:ext cx="759481" cy="904846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Straight Arrow Connector 290"/>
            <p:cNvCxnSpPr/>
            <p:nvPr/>
          </p:nvCxnSpPr>
          <p:spPr>
            <a:xfrm flipV="1">
              <a:off x="4613232" y="1566635"/>
              <a:ext cx="7970" cy="153882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Straight Connector 291"/>
            <p:cNvCxnSpPr/>
            <p:nvPr/>
          </p:nvCxnSpPr>
          <p:spPr>
            <a:xfrm flipH="1" flipV="1">
              <a:off x="3546890" y="5114531"/>
              <a:ext cx="3196753" cy="58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3" name="Straight Connector 292"/>
            <p:cNvCxnSpPr/>
            <p:nvPr/>
          </p:nvCxnSpPr>
          <p:spPr>
            <a:xfrm rot="5400000" flipH="1">
              <a:off x="7145439" y="2351996"/>
              <a:ext cx="208709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4" name="Straight Connector 293"/>
            <p:cNvCxnSpPr/>
            <p:nvPr/>
          </p:nvCxnSpPr>
          <p:spPr>
            <a:xfrm flipH="1" flipV="1">
              <a:off x="4993088" y="1308870"/>
              <a:ext cx="3196753" cy="58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6" name="TextBox 295"/>
            <p:cNvSpPr txBox="1"/>
            <p:nvPr/>
          </p:nvSpPr>
          <p:spPr>
            <a:xfrm>
              <a:off x="7754423" y="3498686"/>
              <a:ext cx="5554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4" name="TextBox 103"/>
          <p:cNvSpPr txBox="1"/>
          <p:nvPr/>
        </p:nvSpPr>
        <p:spPr>
          <a:xfrm>
            <a:off x="829797" y="246157"/>
            <a:ext cx="21750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</a:t>
            </a:r>
            <a:r>
              <a:rPr lang="en-US" sz="1400" b="1" dirty="0" smtClean="0"/>
              <a:t>s10</a:t>
            </a:r>
            <a:r>
              <a:rPr lang="en-US" sz="1400" b="1" dirty="0"/>
              <a:t>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233531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0</TotalTime>
  <Words>106</Words>
  <Application>Microsoft Office PowerPoint</Application>
  <PresentationFormat>Widescreen</PresentationFormat>
  <Paragraphs>9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Ramsden</dc:creator>
  <cp:lastModifiedBy>Richard Ramsden</cp:lastModifiedBy>
  <cp:revision>247</cp:revision>
  <cp:lastPrinted>2016-05-19T16:01:20Z</cp:lastPrinted>
  <dcterms:created xsi:type="dcterms:W3CDTF">2016-01-06T17:18:41Z</dcterms:created>
  <dcterms:modified xsi:type="dcterms:W3CDTF">2016-06-22T19:37:22Z</dcterms:modified>
</cp:coreProperties>
</file>